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7008813" cy="923766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09200" cy="9237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3038400" cy="46188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70440" y="-360"/>
            <a:ext cx="3038400" cy="46188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06800" y="692280"/>
            <a:ext cx="2597040" cy="34639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2880" rIns="9288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1280" y="4387320"/>
            <a:ext cx="5607000" cy="415620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8772120"/>
            <a:ext cx="3038400" cy="46188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70440" y="8772120"/>
            <a:ext cx="3038400" cy="46188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8214376-D522-4AB2-8EBE-211DB4A75B5B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sldImg"/>
          </p:nvPr>
        </p:nvSpPr>
        <p:spPr>
          <a:xfrm>
            <a:off x="2206800" y="692280"/>
            <a:ext cx="2597040" cy="3463920"/>
          </a:xfrm>
          <a:prstGeom prst="rect">
            <a:avLst/>
          </a:prstGeom>
          <a:ln w="0">
            <a:noFill/>
          </a:ln>
        </p:spPr>
      </p:sp>
      <p:sp>
        <p:nvSpPr>
          <p:cNvPr id="60" name="PlaceHolder 2"/>
          <p:cNvSpPr>
            <a:spLocks noGrp="1"/>
          </p:cNvSpPr>
          <p:nvPr>
            <p:ph type="body"/>
          </p:nvPr>
        </p:nvSpPr>
        <p:spPr>
          <a:xfrm>
            <a:off x="701280" y="4387320"/>
            <a:ext cx="5607000" cy="4156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Slide Number Placeholder 3"/>
          <p:cNvSpPr/>
          <p:nvPr/>
        </p:nvSpPr>
        <p:spPr>
          <a:xfrm>
            <a:off x="3970440" y="8772480"/>
            <a:ext cx="3038400" cy="46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880" rIns="9288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E9B4276-5E5F-4A4D-AA27-C9E18EE944E9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F4DA48-9FEC-4617-AEB5-D1643B9CEBC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1D805E-C02B-405C-91BF-913BB226D3B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655735-CB31-49CF-A9E8-1333B84390E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D15CB3-CB72-40A0-9144-0640228D943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7EDF37-C799-46A6-81F5-D7A379ED11A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C7D996-78F0-46A3-9760-2AE4BC600D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DCBB18-5F55-459B-B253-9FDCD4C0B89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81AF2B-DC90-41F0-86A2-D1AABE2D11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403D60-95AE-46D1-B41B-1D9663E4C6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CCBD19-7024-4F54-AC6F-17AFCB7600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B05361-1C3F-4BE5-8C3D-65BF9EC361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4433CA-ADB9-4CEB-AAD1-74C9838013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45D8964-C484-4E21-9704-A00179A1B8F0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51B3063-F1A0-4550-8C47-479B5A5B894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8"/>
          <p:cNvSpPr/>
          <p:nvPr/>
        </p:nvSpPr>
        <p:spPr>
          <a:xfrm>
            <a:off x="-6480" y="6388200"/>
            <a:ext cx="6858000" cy="137268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Figure S2. Features of siRNA-mediated degradation of mRNA in the absence of Ago2. 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(A) Deeper knockdown is achieved by 24h in all Rab5c siRNA treated cells, except MEF Ago2</a:t>
            </a:r>
            <a:r>
              <a:rPr b="0" lang="en-US" sz="1400" spc="-1" strike="noStrike" baseline="30000">
                <a:solidFill>
                  <a:srgbClr val="000000"/>
                </a:solidFill>
                <a:latin typeface="Calibri"/>
              </a:rPr>
              <a:t>-/-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treated with CDS-targeting siRNA, where no significant knockdown is detected at either time point.  Data is presented as mean ± s.d.  for two technical replicates of bDNA measurement.  (B) Complete image of the 5’RACE Nested PCR electrophoresis,  shown in FIGURE 2B, includes two different control reactions for each cell type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4"/>
          <p:cNvSpPr/>
          <p:nvPr/>
        </p:nvSpPr>
        <p:spPr>
          <a:xfrm>
            <a:off x="304920" y="182520"/>
            <a:ext cx="304560" cy="33732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A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5"/>
          <p:cNvSpPr/>
          <p:nvPr/>
        </p:nvSpPr>
        <p:spPr>
          <a:xfrm>
            <a:off x="304920" y="3639960"/>
            <a:ext cx="304560" cy="33732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B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1" name="Picture 2" descr=""/>
          <p:cNvPicPr/>
          <p:nvPr/>
        </p:nvPicPr>
        <p:blipFill>
          <a:blip r:embed="rId1"/>
          <a:stretch/>
        </p:blipFill>
        <p:spPr>
          <a:xfrm>
            <a:off x="380880" y="533520"/>
            <a:ext cx="4572000" cy="2998800"/>
          </a:xfrm>
          <a:prstGeom prst="rect">
            <a:avLst/>
          </a:prstGeom>
          <a:ln w="0">
            <a:noFill/>
          </a:ln>
        </p:spPr>
      </p:pic>
      <p:grpSp>
        <p:nvGrpSpPr>
          <p:cNvPr id="52" name="Group 19"/>
          <p:cNvGrpSpPr/>
          <p:nvPr/>
        </p:nvGrpSpPr>
        <p:grpSpPr>
          <a:xfrm>
            <a:off x="191520" y="3733920"/>
            <a:ext cx="4914000" cy="2066760"/>
            <a:chOff x="191520" y="3733920"/>
            <a:chExt cx="4914000" cy="2066760"/>
          </a:xfrm>
        </p:grpSpPr>
        <p:pic>
          <p:nvPicPr>
            <p:cNvPr id="53" name="Picture 10" descr="chemlab2011-05-24_Rab5c_prepLE_Top_Crop.jpg"/>
            <p:cNvPicPr/>
            <p:nvPr/>
          </p:nvPicPr>
          <p:blipFill>
            <a:blip r:embed="rId2"/>
            <a:stretch/>
          </p:blipFill>
          <p:spPr>
            <a:xfrm>
              <a:off x="686160" y="4419720"/>
              <a:ext cx="4332600" cy="1380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TextBox 13"/>
            <p:cNvSpPr/>
            <p:nvPr/>
          </p:nvSpPr>
          <p:spPr>
            <a:xfrm>
              <a:off x="686160" y="3733920"/>
              <a:ext cx="441936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       </a:t>
              </a:r>
              <a:r>
                <a:rPr b="0" lang="en-US" sz="1600" spc="-1" strike="noStrike" u="sng">
                  <a:solidFill>
                    <a:srgbClr val="000000"/>
                  </a:solidFill>
                  <a:uFillTx/>
                  <a:latin typeface="Calibri"/>
                </a:rPr>
                <a:t>MEF-Ago2fl/fl              .</a:t>
              </a: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     </a:t>
              </a:r>
              <a:r>
                <a:rPr b="0" lang="en-US" sz="1600" spc="-1" strike="noStrike" u="sng">
                  <a:solidFill>
                    <a:srgbClr val="000000"/>
                  </a:solidFill>
                  <a:uFillTx/>
                  <a:latin typeface="Calibri"/>
                </a:rPr>
                <a:t>MEF-Ago2-/-              . 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M   Luc     other     UTRn     Luc     other   UTRn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55" name="Straight Arrow Connector 12"/>
            <p:cNvCxnSpPr/>
            <p:nvPr/>
          </p:nvCxnSpPr>
          <p:spPr>
            <a:xfrm>
              <a:off x="730440" y="5143680"/>
              <a:ext cx="49320" cy="1080"/>
            </a:xfrm>
            <a:prstGeom prst="straightConnector1">
              <a:avLst/>
            </a:prstGeom>
            <a:ln w="19080">
              <a:solidFill>
                <a:srgbClr val="ffffff"/>
              </a:solidFill>
              <a:miter/>
              <a:tailEnd len="med" type="triangle" w="med"/>
            </a:ln>
          </p:spPr>
        </p:cxnSp>
        <p:cxnSp>
          <p:nvCxnSpPr>
            <p:cNvPr id="56" name="Straight Arrow Connector 16"/>
            <p:cNvCxnSpPr/>
            <p:nvPr/>
          </p:nvCxnSpPr>
          <p:spPr>
            <a:xfrm>
              <a:off x="713880" y="5477760"/>
              <a:ext cx="66240" cy="1080"/>
            </a:xfrm>
            <a:prstGeom prst="straightConnector1">
              <a:avLst/>
            </a:prstGeom>
            <a:ln w="19080">
              <a:solidFill>
                <a:srgbClr val="ffffff"/>
              </a:solidFill>
              <a:miter/>
              <a:tailEnd len="med" type="triangle" w="med"/>
            </a:ln>
          </p:spPr>
        </p:cxnSp>
        <p:sp>
          <p:nvSpPr>
            <p:cNvPr id="57" name="TextBox 17"/>
            <p:cNvSpPr/>
            <p:nvPr/>
          </p:nvSpPr>
          <p:spPr>
            <a:xfrm>
              <a:off x="191520" y="5339520"/>
              <a:ext cx="57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100bp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18"/>
            <p:cNvSpPr/>
            <p:nvPr/>
          </p:nvSpPr>
          <p:spPr>
            <a:xfrm>
              <a:off x="191520" y="5005440"/>
              <a:ext cx="57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500bp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05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9-03T01:32:11Z</dcterms:created>
  <dc:creator>Vera Ruda</dc:creator>
  <dc:description/>
  <dc:language>en-US</dc:language>
  <cp:lastModifiedBy>Vera Ruda</cp:lastModifiedBy>
  <dcterms:modified xsi:type="dcterms:W3CDTF">2013-12-17T07:57:44Z</dcterms:modified>
  <cp:revision>468</cp:revision>
  <dc:subject/>
  <dc:title>Molecular  Biology  of  RISC Substrate  Specificity in vivo or  The roles of individual Argonautes in RNAi in vivo</dc:title>
</cp:coreProperties>
</file>